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6"/>
  </p:normalViewPr>
  <p:slideViewPr>
    <p:cSldViewPr snapToGrid="0" snapToObjects="1">
      <p:cViewPr varScale="1">
        <p:scale>
          <a:sx n="67" d="100"/>
          <a:sy n="67" d="100"/>
        </p:scale>
        <p:origin x="620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55495D3-4678-1A4C-A34B-7220A82F13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531BE19-EAC9-ED4E-8B4B-729743B7D1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2CE9607-1C05-D14E-BB6B-63DC7D73F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53B4105-AD72-D84A-A9B6-CB4782F1D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9E684F9-B760-E346-946C-3AD1597ED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627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FEC83DE-030C-D84A-9739-3F0C8B5A2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2F03153C-8104-B04F-928A-026D606EC6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0D39AE2-6EA3-034C-BF42-5C4B9073F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BE1CF37-9C8F-8644-8AF0-3FC5574F7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FD4128F-433E-0549-A7F6-121F27BBE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489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7D4584FA-846E-3145-B68B-5C22E2DB30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0BA2A74-9F2C-6A42-99E9-4F116E6ECF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D668F1C-46B2-C444-91F1-44A1F6131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FDDF351-7D80-1B40-A5E4-0772337CD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09B36E5-4C92-194D-994A-E999F5A50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434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89AC477-AF43-9F42-B1CA-7B37BD2D05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FF286EE-0AE5-1942-92FD-E6C4D4CAD2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A2B4D93-1677-F44E-BE18-51307C234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37EE865-0740-E642-95F6-051D42C08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B0212D1-4A4F-9E44-B3B7-F87E90EE6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000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A47B7E5-A080-8749-99F1-8B1D1AA62A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89F49A0-4D6A-F749-A21D-A28E4E7B63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33E022C-48D4-DB42-9ECD-FAFED324F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EE70C68-69C1-934C-9D6B-6F7014EC7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D3B38F2-2AEB-2F49-A24D-19D4A9DDD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624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B864DDF-026E-C941-8742-BBB5DA37E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5A13ACF-B98C-644D-8188-648AD1453F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6036ECC-C54F-9540-8C52-913339EC91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65CD3DC-8E1E-FF49-AC3A-1080609B3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3040C2F-E6D0-3A44-876D-9E1490A26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E679312-8DDD-9E40-9930-3DAC6D885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15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E35348E-D98B-1540-A1D4-6B9150DAC0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A911D2D-8D8A-6B4A-ADEF-ADD3665F10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17EA477-56F8-294B-8BF7-FDD86F0F4C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30EB020B-3125-164E-9512-3C5C2EE90B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DA8ED6D5-F2BA-F84A-B924-D2747E6053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2833763C-4108-1041-80C9-C643E58CE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1C847760-B52F-1B48-9F45-3B17E0DE7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88EE1EC3-7F12-D44A-8543-C8E793F39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618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2442091-79A8-A641-9E8C-520F8EA926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F2F6D1E1-81E6-794C-A4C4-410CDAAB5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C91794E-6856-694C-A125-5A75C7191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62D1C91B-0B34-1049-A721-189ADF003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192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7EE8B9A4-3BC3-644A-9B9A-DE37B29C4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CF793F07-6DC2-944E-9BD1-039D3387C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51A25F30-BAA0-5843-AA8A-0E5FA1144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291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A98E03C-ADBC-E54D-AB3B-622C965410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57ACD3C-A9B1-1C40-B9EF-78BA8C5CEE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297F0B6-0466-4042-BB08-5DF3D9C77A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2F231C1-83AA-074B-8B8E-42DFA8834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7497B04-91D4-A44F-AE13-3ABF03390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526F595-2B2C-F447-B42B-B86EC86F2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165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FE0F619-A9BC-764B-8DF1-2FCDDB1231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62A23B63-0683-0049-8614-0A1F18B497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BCF16A73-40F0-6A40-B256-24F0BF7B22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02A443F-E08D-7545-91E3-C1E451DED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5FBFF88-F262-0D46-B5F6-FDCFF033F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4D7D073-AD69-404B-892A-488B0C441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895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13ABB851-8F06-E84F-90A6-F397D2AE9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C3683A1-22ED-8648-8ACC-E0114AF40B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EA5231E-7A2F-D246-8CF5-F68A19D02F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373A62-095A-614A-A554-FEAA0323BCD8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00C677E-0BD2-404E-854E-F651E3A7E4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D117897-9AC8-4E4A-A3E9-C18AE4EF81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3CB047-FD06-2C41-9EFC-4706A6DD8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490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xmlns="" id="{C3283614-BA97-EB4C-B9F8-001932A9288C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985846" y="140678"/>
            <a:ext cx="3788075" cy="6073856"/>
          </a:xfrm>
          <a:prstGeom prst="rect">
            <a:avLst/>
          </a:prstGeom>
          <a:noFill/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175F43AE-0B01-7C4E-9A91-3FC7E592FEB8}"/>
              </a:ext>
            </a:extLst>
          </p:cNvPr>
          <p:cNvSpPr/>
          <p:nvPr/>
        </p:nvSpPr>
        <p:spPr>
          <a:xfrm>
            <a:off x="3047999" y="6214534"/>
            <a:ext cx="6389077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l </a:t>
            </a:r>
            <a:r>
              <a:rPr lang="en-US" sz="100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sz="100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4: </a:t>
            </a:r>
            <a:r>
              <a:rPr lang="en-US" sz="10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cytotoxic effect of a Cannabis extract, THC_EX3 on the viability of ACRJ-CP28 and PC3 cell line.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 viability was determined using the MTS assay and OD readings were taken a 409nm. Plots were generated in Microsoft Excel and each data point represents the average of three replicates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 shown are representative of two independent experiments.</a:t>
            </a:r>
            <a:endParaRPr lang="en-US" sz="10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6882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6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Badal</dc:creator>
  <cp:lastModifiedBy>Valentine, Henkel L</cp:lastModifiedBy>
  <cp:revision>9</cp:revision>
  <dcterms:created xsi:type="dcterms:W3CDTF">2020-09-18T16:29:38Z</dcterms:created>
  <dcterms:modified xsi:type="dcterms:W3CDTF">2022-06-20T04:28:03Z</dcterms:modified>
</cp:coreProperties>
</file>